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8892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oup 37">
            <a:extLst>
              <a:ext uri="{FF2B5EF4-FFF2-40B4-BE49-F238E27FC236}">
                <a16:creationId xmlns="" xmlns:a16="http://schemas.microsoft.com/office/drawing/2014/main" id="{48FA2DA7-DC45-CF47-ACDB-7C4EB5A001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2005388"/>
              </p:ext>
            </p:extLst>
          </p:nvPr>
        </p:nvGraphicFramePr>
        <p:xfrm>
          <a:off x="211067" y="2531101"/>
          <a:ext cx="6257190" cy="3322557"/>
        </p:xfrm>
        <a:graphic>
          <a:graphicData uri="http://schemas.openxmlformats.org/drawingml/2006/table">
            <a:tbl>
              <a:tblPr/>
              <a:tblGrid>
                <a:gridCol w="3130896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12629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651901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Tested strains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Dry cell weight (mg/L)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of absorbance at 660 nm ≒ 1.6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Lactobacillus acidophilu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NRIC1547</a:t>
                      </a:r>
                      <a:r>
                        <a:rPr kumimoji="1" lang="en-US" altLang="ja-JP" sz="10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T</a:t>
                      </a:r>
                      <a:endParaRPr kumimoji="1" lang="en-US" altLang="ja-JP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50" charset="-128"/>
                      </a:endParaRP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732.5 ± 86.1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Streptococcus thermophilu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NRIC0256</a:t>
                      </a:r>
                      <a:r>
                        <a:rPr kumimoji="1" lang="en-US" altLang="ja-JP" sz="10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T</a:t>
                      </a:r>
                      <a:endParaRPr kumimoji="1" lang="en-US" altLang="ja-JP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50" charset="-128"/>
                      </a:endParaRP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710.9 ±  23.6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Lactobacillus plantarum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NRIC1067</a:t>
                      </a:r>
                      <a:r>
                        <a:rPr kumimoji="1" lang="en-US" altLang="ja-JP" sz="10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T</a:t>
                      </a:r>
                      <a:endParaRPr kumimoji="1" lang="en-US" altLang="ja-JP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50" charset="-128"/>
                      </a:endParaRP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665.6 ±  17.7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9099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　　</a:t>
                      </a: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Lactobacillus plantarum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P1-2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811.6 ± 51.3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9099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Pediococcus pentosaceu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NRIC0099</a:t>
                      </a:r>
                      <a:r>
                        <a:rPr kumimoji="1" lang="en-US" altLang="ja-JP" sz="10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T</a:t>
                      </a:r>
                      <a:endParaRPr kumimoji="1" lang="en-US" altLang="ja-JP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50" charset="-128"/>
                      </a:endParaRP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577.6</a:t>
                      </a:r>
                      <a:r>
                        <a:rPr kumimoji="1" lang="ja-JP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　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±  26.4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Pediococcus pentosaceu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Be1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577.6 ±   26.4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Bacillus subtili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NRIC1015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692.8 ± 28.9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4811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     Escherichia coli 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NRIC1518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50" charset="-128"/>
                        </a:rPr>
                        <a:t>715.8 ± 9.9</a:t>
                      </a:r>
                    </a:p>
                  </a:txBody>
                  <a:tcPr marT="45730" marB="4573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" name="Rectangle 34">
            <a:extLst>
              <a:ext uri="{FF2B5EF4-FFF2-40B4-BE49-F238E27FC236}">
                <a16:creationId xmlns="" xmlns:a16="http://schemas.microsoft.com/office/drawing/2014/main" id="{81BDA44D-E466-AE4D-A146-21E1E9FDD4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6377" y="2081255"/>
            <a:ext cx="292657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Times New Roman" panose="02020603050405020304" pitchFamily="18" charset="0"/>
              </a:rPr>
              <a:t>S1 Table.  Dry cell weight of tested strains</a:t>
            </a:r>
          </a:p>
        </p:txBody>
      </p:sp>
    </p:spTree>
    <p:extLst>
      <p:ext uri="{BB962C8B-B14F-4D97-AF65-F5344CB8AC3E}">
        <p14:creationId xmlns:p14="http://schemas.microsoft.com/office/powerpoint/2010/main" val="3560354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75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2:29Z</dcterms:modified>
</cp:coreProperties>
</file>